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81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49" d="100"/>
          <a:sy n="49" d="100"/>
        </p:scale>
        <p:origin x="289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217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5187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255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173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743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4404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8672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452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44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992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224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90F2BB-0421-4262-AFB8-6E082AABC816}" type="datetimeFigureOut">
              <a:rPr lang="en-US" smtClean="0"/>
              <a:t>12/1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852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C02CA40B-6230-461C-B25C-36982B6311C6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244104" y="3898076"/>
          <a:ext cx="5193008" cy="31335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8" r:id="rId3" imgW="4558680" imgH="3136320" progId="">
                  <p:embed/>
                </p:oleObj>
              </mc:Choice>
              <mc:Fallback>
                <p:oleObj r:id="rId3" imgW="4558680" imgH="3136320" progId="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C02CA40B-6230-461C-B25C-36982B6311C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244104" y="3898076"/>
                        <a:ext cx="5193008" cy="31335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7CDB739C-6ACF-4CDF-B7D8-EAD74C9F3926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925522" y="5588667"/>
          <a:ext cx="447989" cy="6260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9" r:id="rId5" imgW="495000" imgH="698400" progId="">
                  <p:embed/>
                </p:oleObj>
              </mc:Choice>
              <mc:Fallback>
                <p:oleObj r:id="rId5" imgW="495000" imgH="698400" progId="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7CDB739C-6ACF-4CDF-B7D8-EAD74C9F392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925522" y="5588667"/>
                        <a:ext cx="447989" cy="6260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8F9586B1-D443-41D5-A354-102C6D5EEB74}"/>
              </a:ext>
            </a:extLst>
          </p:cNvPr>
          <p:cNvSpPr txBox="1"/>
          <p:nvPr/>
        </p:nvSpPr>
        <p:spPr>
          <a:xfrm>
            <a:off x="5238579" y="5539158"/>
            <a:ext cx="559769" cy="3111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A892B5F-6726-46B5-AF2A-2812E37EC632}"/>
              </a:ext>
            </a:extLst>
          </p:cNvPr>
          <p:cNvSpPr txBox="1"/>
          <p:nvPr/>
        </p:nvSpPr>
        <p:spPr>
          <a:xfrm>
            <a:off x="5230319" y="5871295"/>
            <a:ext cx="971741" cy="3111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WT CTL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2AFFBBE-A01C-481A-83E4-B060B35F86B9}"/>
              </a:ext>
            </a:extLst>
          </p:cNvPr>
          <p:cNvSpPr txBox="1"/>
          <p:nvPr/>
        </p:nvSpPr>
        <p:spPr>
          <a:xfrm>
            <a:off x="5804425" y="7003655"/>
            <a:ext cx="149432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ays elapse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EE6E0B4-987B-4DC9-A034-0E621A374177}"/>
              </a:ext>
            </a:extLst>
          </p:cNvPr>
          <p:cNvSpPr txBox="1"/>
          <p:nvPr/>
        </p:nvSpPr>
        <p:spPr>
          <a:xfrm>
            <a:off x="1603962" y="7527481"/>
            <a:ext cx="9304276" cy="995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956" b="1" dirty="0">
                <a:latin typeface="Arial" panose="020B0604020202020204" pitchFamily="34" charset="0"/>
                <a:cs typeface="Arial" panose="020B0604020202020204" pitchFamily="34" charset="0"/>
              </a:rPr>
              <a:t>Fig. S3. Survival plots of mice with </a:t>
            </a:r>
            <a:r>
              <a:rPr lang="en-US" sz="1956" b="1" dirty="0" err="1">
                <a:latin typeface="Arial" panose="020B0604020202020204" pitchFamily="34" charset="0"/>
                <a:cs typeface="Arial" panose="020B0604020202020204" pitchFamily="34" charset="0"/>
              </a:rPr>
              <a:t>s.c.</a:t>
            </a:r>
            <a:r>
              <a:rPr lang="en-US" sz="1956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956" b="1" dirty="0" err="1">
                <a:latin typeface="Arial" panose="020B0604020202020204" pitchFamily="34" charset="0"/>
                <a:cs typeface="Arial" panose="020B0604020202020204" pitchFamily="34" charset="0"/>
              </a:rPr>
              <a:t>s.c.</a:t>
            </a:r>
            <a:r>
              <a:rPr lang="en-US" sz="1956" b="1" dirty="0">
                <a:latin typeface="Arial" panose="020B0604020202020204" pitchFamily="34" charset="0"/>
                <a:cs typeface="Arial" panose="020B0604020202020204" pitchFamily="34" charset="0"/>
              </a:rPr>
              <a:t> melanomas treated with PBS or wildtype (WT) CD8+ T cells injected into the </a:t>
            </a:r>
            <a:r>
              <a:rPr lang="en-US" sz="1956" b="1" dirty="0" err="1">
                <a:latin typeface="Arial" panose="020B0604020202020204" pitchFamily="34" charset="0"/>
                <a:cs typeface="Arial" panose="020B0604020202020204" pitchFamily="34" charset="0"/>
              </a:rPr>
              <a:t>s.c.</a:t>
            </a:r>
            <a:r>
              <a:rPr lang="en-US" sz="1956" b="1" dirty="0">
                <a:latin typeface="Arial" panose="020B0604020202020204" pitchFamily="34" charset="0"/>
                <a:cs typeface="Arial" panose="020B0604020202020204" pitchFamily="34" charset="0"/>
              </a:rPr>
              <a:t> Tumor 1. </a:t>
            </a:r>
            <a:r>
              <a:rPr lang="en-US" sz="1956" dirty="0">
                <a:latin typeface="Arial" panose="020B0604020202020204" pitchFamily="34" charset="0"/>
                <a:cs typeface="Arial" panose="020B0604020202020204" pitchFamily="34" charset="0"/>
              </a:rPr>
              <a:t>PBS: n=8; WT CTLs: n=5. ns: not significant (p &gt; 0.05). log-rank test.</a:t>
            </a:r>
            <a:endParaRPr lang="en-US" sz="1956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F437F86-D3A0-4B01-B9F2-A4280E256ABC}"/>
              </a:ext>
            </a:extLst>
          </p:cNvPr>
          <p:cNvSpPr txBox="1"/>
          <p:nvPr/>
        </p:nvSpPr>
        <p:spPr>
          <a:xfrm rot="16200000">
            <a:off x="2673001" y="5291678"/>
            <a:ext cx="27318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Probability of Survival (%)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9256523E-72F8-44D1-B9CC-D2D9A73C31B9}"/>
              </a:ext>
            </a:extLst>
          </p:cNvPr>
          <p:cNvCxnSpPr>
            <a:cxnSpLocks/>
          </p:cNvCxnSpPr>
          <p:nvPr/>
        </p:nvCxnSpPr>
        <p:spPr>
          <a:xfrm>
            <a:off x="6363520" y="5715602"/>
            <a:ext cx="0" cy="2983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C1E439AA-6B53-48A4-9CBA-3611C2FED140}"/>
              </a:ext>
            </a:extLst>
          </p:cNvPr>
          <p:cNvSpPr txBox="1"/>
          <p:nvPr/>
        </p:nvSpPr>
        <p:spPr>
          <a:xfrm>
            <a:off x="6256100" y="5666111"/>
            <a:ext cx="60713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</p:spTree>
    <p:extLst>
      <p:ext uri="{BB962C8B-B14F-4D97-AF65-F5344CB8AC3E}">
        <p14:creationId xmlns:p14="http://schemas.microsoft.com/office/powerpoint/2010/main" val="36757831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75</Words>
  <Application>Microsoft Office PowerPoint</Application>
  <PresentationFormat>Custom</PresentationFormat>
  <Paragraphs>6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ng,Hong</dc:creator>
  <cp:lastModifiedBy>Jiang,Hong</cp:lastModifiedBy>
  <cp:revision>5</cp:revision>
  <dcterms:created xsi:type="dcterms:W3CDTF">2022-10-17T17:34:53Z</dcterms:created>
  <dcterms:modified xsi:type="dcterms:W3CDTF">2022-12-14T16:05:44Z</dcterms:modified>
</cp:coreProperties>
</file>